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7008813" cy="923766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009200" cy="9237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-360"/>
            <a:ext cx="3038400" cy="461880"/>
          </a:xfrm>
          <a:prstGeom prst="rect">
            <a:avLst/>
          </a:prstGeom>
          <a:noFill/>
          <a:ln w="0">
            <a:noFill/>
          </a:ln>
        </p:spPr>
        <p:txBody>
          <a:bodyPr lIns="92880" rIns="92880" tIns="46440" bIns="464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970440" y="-360"/>
            <a:ext cx="3038400" cy="461880"/>
          </a:xfrm>
          <a:prstGeom prst="rect">
            <a:avLst/>
          </a:prstGeom>
          <a:noFill/>
          <a:ln w="0">
            <a:noFill/>
          </a:ln>
        </p:spPr>
        <p:txBody>
          <a:bodyPr lIns="92880" rIns="92880" tIns="46440" bIns="4644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06800" y="692280"/>
            <a:ext cx="2597040" cy="34639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2880" rIns="92880" tIns="46440" bIns="4644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01280" y="4387320"/>
            <a:ext cx="5607000" cy="4156200"/>
          </a:xfrm>
          <a:prstGeom prst="rect">
            <a:avLst/>
          </a:prstGeom>
          <a:noFill/>
          <a:ln w="0">
            <a:noFill/>
          </a:ln>
        </p:spPr>
        <p:txBody>
          <a:bodyPr lIns="92880" rIns="92880" tIns="46440" bIns="4644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8772120"/>
            <a:ext cx="3038400" cy="461880"/>
          </a:xfrm>
          <a:prstGeom prst="rect">
            <a:avLst/>
          </a:prstGeom>
          <a:noFill/>
          <a:ln w="0">
            <a:noFill/>
          </a:ln>
        </p:spPr>
        <p:txBody>
          <a:bodyPr lIns="92880" rIns="92880" tIns="46440" bIns="4644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970440" y="8772120"/>
            <a:ext cx="3038400" cy="461880"/>
          </a:xfrm>
          <a:prstGeom prst="rect">
            <a:avLst/>
          </a:prstGeom>
          <a:noFill/>
          <a:ln w="0">
            <a:noFill/>
          </a:ln>
        </p:spPr>
        <p:txBody>
          <a:bodyPr lIns="92880" rIns="92880" tIns="46440" bIns="4644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4DFF19A-6B0D-4DE9-9BAF-816979C08CED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PlaceHolder 1"/>
          <p:cNvSpPr>
            <a:spLocks noGrp="1"/>
          </p:cNvSpPr>
          <p:nvPr>
            <p:ph type="sldImg"/>
          </p:nvPr>
        </p:nvSpPr>
        <p:spPr>
          <a:xfrm>
            <a:off x="2206800" y="692280"/>
            <a:ext cx="2597040" cy="3463920"/>
          </a:xfrm>
          <a:prstGeom prst="rect">
            <a:avLst/>
          </a:prstGeom>
          <a:ln w="0">
            <a:noFill/>
          </a:ln>
        </p:spPr>
      </p:sp>
      <p:sp>
        <p:nvSpPr>
          <p:cNvPr id="53" name="PlaceHolder 2"/>
          <p:cNvSpPr>
            <a:spLocks noGrp="1"/>
          </p:cNvSpPr>
          <p:nvPr>
            <p:ph type="body"/>
          </p:nvPr>
        </p:nvSpPr>
        <p:spPr>
          <a:xfrm>
            <a:off x="701280" y="4387320"/>
            <a:ext cx="5607000" cy="4156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Slide Number Placeholder 3"/>
          <p:cNvSpPr/>
          <p:nvPr/>
        </p:nvSpPr>
        <p:spPr>
          <a:xfrm>
            <a:off x="3970440" y="8772480"/>
            <a:ext cx="3038400" cy="461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880" rIns="9288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D9D0EE5-1D5D-480A-80AB-D8ACF7EFF25C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F3FC17-D443-44FA-988A-91E9BF08ECD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32EB51-749E-4524-9BB2-C0E448D19E5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92A1AB-2B3A-4E55-92BA-98A5B890889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40DF0B-52AC-4C99-8032-272C37C444B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8256C1-5FF2-4A74-A2B6-547F8EAA660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207B81-F9F6-4DB3-B611-869B9CCA350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B8B8BC-5673-41E3-A8B7-C6800396E40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86CA5C-BF20-4CCD-BE64-C340AC9DB0D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93C8A6-475A-4C87-84D4-495939BC395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BA3F6D-61B0-4296-8B61-8BDFF17250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C53605-258E-40AB-9510-353B3A9643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22F09D-99A6-4AE9-9C34-445308472B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BDC2E34-7209-4E32-9E96-41DA2CA891A5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6046F96-4FD5-4528-B837-44B90D2D141F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2"/>
          <p:cNvGrpSpPr/>
          <p:nvPr/>
        </p:nvGrpSpPr>
        <p:grpSpPr>
          <a:xfrm>
            <a:off x="96840" y="762120"/>
            <a:ext cx="6553080" cy="6705360"/>
            <a:chOff x="96840" y="762120"/>
            <a:chExt cx="6553080" cy="6705360"/>
          </a:xfrm>
        </p:grpSpPr>
        <p:pic>
          <p:nvPicPr>
            <p:cNvPr id="49" name="Picture 6" descr=""/>
            <p:cNvPicPr/>
            <p:nvPr/>
          </p:nvPicPr>
          <p:blipFill>
            <a:blip r:embed="rId1"/>
            <a:stretch/>
          </p:blipFill>
          <p:spPr>
            <a:xfrm>
              <a:off x="96840" y="762120"/>
              <a:ext cx="3221640" cy="6667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0" name="Picture 7" descr=""/>
            <p:cNvPicPr/>
            <p:nvPr/>
          </p:nvPicPr>
          <p:blipFill>
            <a:blip r:embed="rId2"/>
            <a:stretch/>
          </p:blipFill>
          <p:spPr>
            <a:xfrm>
              <a:off x="3427200" y="799200"/>
              <a:ext cx="3222720" cy="666828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51" name="Rectangle 5"/>
          <p:cNvSpPr/>
          <p:nvPr/>
        </p:nvSpPr>
        <p:spPr>
          <a:xfrm>
            <a:off x="19080" y="8001000"/>
            <a:ext cx="6858000" cy="946440"/>
          </a:xfrm>
          <a:prstGeom prst="rect">
            <a:avLst/>
          </a:pr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Figure S3. 5’RACE products’ sequences alignment. 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Sequenced cloned PCR products were aligned to mouse Rab5c mRNA NM_024456.3 (by APE software).  mRNA sequence complementary to </a:t>
            </a:r>
            <a:r>
              <a:rPr b="0" lang="en-US" sz="1400" spc="-1" strike="noStrike" u="sng">
                <a:solidFill>
                  <a:srgbClr val="000000"/>
                </a:solidFill>
                <a:uFillTx/>
                <a:latin typeface="Calibri"/>
              </a:rPr>
              <a:t>Rab5c-3’UTR-near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 siRNA is highlighted green (cleavage site marked with an asterisk)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05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9-03T01:32:11Z</dcterms:created>
  <dc:creator>Vera Ruda</dc:creator>
  <dc:description/>
  <dc:language>en-US</dc:language>
  <cp:lastModifiedBy>Vera Ruda</cp:lastModifiedBy>
  <dcterms:modified xsi:type="dcterms:W3CDTF">2013-12-17T07:58:59Z</dcterms:modified>
  <cp:revision>468</cp:revision>
  <dc:subject/>
  <dc:title>Molecular  Biology  of  RISC Substrate  Specificity in vivo or  The roles of individual Argonautes in RNAi in vivo</dc:title>
</cp:coreProperties>
</file>